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10" r:id="rId2"/>
  </p:sldIdLst>
  <p:sldSz cx="9601200" cy="12801600" type="A3"/>
  <p:notesSz cx="6858000" cy="9144000"/>
  <p:defaultTextStyle>
    <a:defPPr>
      <a:defRPr lang="en-US"/>
    </a:defPPr>
    <a:lvl1pPr marL="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32" userDrawn="1">
          <p15:clr>
            <a:srgbClr val="A4A3A4"/>
          </p15:clr>
        </p15:guide>
        <p15:guide id="2" pos="30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CEBEB"/>
    <a:srgbClr val="FEFF1C"/>
    <a:srgbClr val="FF9700"/>
    <a:srgbClr val="FFB502"/>
    <a:srgbClr val="FF0100"/>
    <a:srgbClr val="FFD302"/>
    <a:srgbClr val="FCB301"/>
    <a:srgbClr val="F69102"/>
    <a:srgbClr val="FFFF1B"/>
    <a:srgbClr val="F054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387"/>
    <p:restoredTop sz="95073"/>
  </p:normalViewPr>
  <p:slideViewPr>
    <p:cSldViewPr snapToGrid="0" snapToObjects="1">
      <p:cViewPr>
        <p:scale>
          <a:sx n="115" d="100"/>
          <a:sy n="115" d="100"/>
        </p:scale>
        <p:origin x="2728" y="-2720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82A022-C9F4-0148-975C-F94539B6FB3D}" type="datetimeFigureOut">
              <a:rPr lang="en-US" smtClean="0"/>
              <a:t>5/19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5F2F5C-3AD8-114A-9235-54C4AB861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9318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19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19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19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3556F7-2C12-5140-B74C-9CF7B726B924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473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AAA8446-465B-4B46-A4A7-82A6E9D40DAF}"/>
              </a:ext>
            </a:extLst>
          </p:cNvPr>
          <p:cNvSpPr txBox="1"/>
          <p:nvPr/>
        </p:nvSpPr>
        <p:spPr>
          <a:xfrm>
            <a:off x="579664" y="11601227"/>
            <a:ext cx="84418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analysis of carotenoid biosynthetic and metabolism genes during postharvest peel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greening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response to propylene or different storage temperatures. Data points represent the mean (± SE) of five fruit and different letters indicate significant differences in ANOVA (Tukey’s test, p &lt; 0.05). </a:t>
            </a:r>
            <a:r>
              <a:rPr lang="en-GB" sz="12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DAFB – Days after full bloom.</a:t>
            </a: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56D8E1CF-5E43-F04C-A05E-C5CDED88F3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5410" y="720151"/>
            <a:ext cx="4463740" cy="10881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35571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787</TotalTime>
  <Words>59</Words>
  <Application>Microsoft Macintosh PowerPoint</Application>
  <PresentationFormat>A3 Paper (297x420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TALO Oscar　Witere</dc:creator>
  <cp:keywords/>
  <dc:description/>
  <cp:lastModifiedBy>Oscar Witere Mitalo</cp:lastModifiedBy>
  <cp:revision>1498</cp:revision>
  <cp:lastPrinted>2022-02-28T04:45:31Z</cp:lastPrinted>
  <dcterms:created xsi:type="dcterms:W3CDTF">2018-04-12T04:09:11Z</dcterms:created>
  <dcterms:modified xsi:type="dcterms:W3CDTF">2022-05-20T02:33:09Z</dcterms:modified>
  <cp:category/>
</cp:coreProperties>
</file>